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6" r:id="rId2"/>
    <p:sldId id="267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782"/>
    <p:restoredTop sz="94698"/>
  </p:normalViewPr>
  <p:slideViewPr>
    <p:cSldViewPr snapToGrid="0" snapToObjects="1">
      <p:cViewPr varScale="1">
        <p:scale>
          <a:sx n="161" d="100"/>
          <a:sy n="161" d="100"/>
        </p:scale>
        <p:origin x="216" y="5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F30F2-7163-8942-8D11-A9718679C3A6}" type="datetimeFigureOut">
              <a:rPr lang="en-US" smtClean="0"/>
              <a:t>9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DCF98-C68E-304C-B90E-95AEC8B32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3160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F30F2-7163-8942-8D11-A9718679C3A6}" type="datetimeFigureOut">
              <a:rPr lang="en-US" smtClean="0"/>
              <a:t>9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DCF98-C68E-304C-B90E-95AEC8B32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51386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F30F2-7163-8942-8D11-A9718679C3A6}" type="datetimeFigureOut">
              <a:rPr lang="en-US" smtClean="0"/>
              <a:t>9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DCF98-C68E-304C-B90E-95AEC8B32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23219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F30F2-7163-8942-8D11-A9718679C3A6}" type="datetimeFigureOut">
              <a:rPr lang="en-US" smtClean="0"/>
              <a:t>9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DCF98-C68E-304C-B90E-95AEC8B32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07975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F30F2-7163-8942-8D11-A9718679C3A6}" type="datetimeFigureOut">
              <a:rPr lang="en-US" smtClean="0"/>
              <a:t>9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DCF98-C68E-304C-B90E-95AEC8B32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8338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F30F2-7163-8942-8D11-A9718679C3A6}" type="datetimeFigureOut">
              <a:rPr lang="en-US" smtClean="0"/>
              <a:t>9/2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DCF98-C68E-304C-B90E-95AEC8B32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68875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F30F2-7163-8942-8D11-A9718679C3A6}" type="datetimeFigureOut">
              <a:rPr lang="en-US" smtClean="0"/>
              <a:t>9/28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DCF98-C68E-304C-B90E-95AEC8B32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01963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F30F2-7163-8942-8D11-A9718679C3A6}" type="datetimeFigureOut">
              <a:rPr lang="en-US" smtClean="0"/>
              <a:t>9/28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DCF98-C68E-304C-B90E-95AEC8B32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33281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F30F2-7163-8942-8D11-A9718679C3A6}" type="datetimeFigureOut">
              <a:rPr lang="en-US" smtClean="0"/>
              <a:t>9/28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DCF98-C68E-304C-B90E-95AEC8B32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7382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F30F2-7163-8942-8D11-A9718679C3A6}" type="datetimeFigureOut">
              <a:rPr lang="en-US" smtClean="0"/>
              <a:t>9/2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DCF98-C68E-304C-B90E-95AEC8B32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91155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F30F2-7163-8942-8D11-A9718679C3A6}" type="datetimeFigureOut">
              <a:rPr lang="en-US" smtClean="0"/>
              <a:t>9/2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7DCF98-C68E-304C-B90E-95AEC8B32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84329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EF30F2-7163-8942-8D11-A9718679C3A6}" type="datetimeFigureOut">
              <a:rPr lang="en-US" smtClean="0"/>
              <a:t>9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7DCF98-C68E-304C-B90E-95AEC8B32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82951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>
            <a:extLst>
              <a:ext uri="{FF2B5EF4-FFF2-40B4-BE49-F238E27FC236}">
                <a16:creationId xmlns:a16="http://schemas.microsoft.com/office/drawing/2014/main" id="{8C41E6CA-1232-1E47-BB43-E41458CD2000}"/>
              </a:ext>
            </a:extLst>
          </p:cNvPr>
          <p:cNvGrpSpPr/>
          <p:nvPr/>
        </p:nvGrpSpPr>
        <p:grpSpPr>
          <a:xfrm>
            <a:off x="1264258" y="246490"/>
            <a:ext cx="6687048" cy="5502304"/>
            <a:chOff x="222637" y="238539"/>
            <a:chExt cx="6687048" cy="5502304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D8A2F7DF-E854-2E45-8ACF-C8E31F944FF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12013" t="13101" r="12641" b="6667"/>
            <a:stretch/>
          </p:blipFill>
          <p:spPr>
            <a:xfrm>
              <a:off x="222637" y="238539"/>
              <a:ext cx="6687048" cy="5502304"/>
            </a:xfrm>
            <a:prstGeom prst="rect">
              <a:avLst/>
            </a:prstGeom>
          </p:spPr>
        </p:pic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F7A44686-6B63-B448-98FF-63E1FAE5B076}"/>
                </a:ext>
              </a:extLst>
            </p:cNvPr>
            <p:cNvSpPr/>
            <p:nvPr/>
          </p:nvSpPr>
          <p:spPr>
            <a:xfrm>
              <a:off x="238539" y="1781092"/>
              <a:ext cx="5518205" cy="164592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926B34BC-C658-6B4A-B12D-77BDC1BFA6D3}"/>
              </a:ext>
            </a:extLst>
          </p:cNvPr>
          <p:cNvSpPr txBox="1"/>
          <p:nvPr/>
        </p:nvSpPr>
        <p:spPr>
          <a:xfrm>
            <a:off x="723569" y="6015726"/>
            <a:ext cx="794335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2-DE spots that were identified by MS/MS. Panel A shows the entire 2-D gel while panel B shows an enlarged version of the region enclosed in the box.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8E6E44B-55A5-F148-A46B-EA868FFB0FDD}"/>
              </a:ext>
            </a:extLst>
          </p:cNvPr>
          <p:cNvSpPr txBox="1"/>
          <p:nvPr/>
        </p:nvSpPr>
        <p:spPr>
          <a:xfrm>
            <a:off x="1288115" y="254441"/>
            <a:ext cx="2623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34973815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2FC769C-7975-BE44-AEBC-13CAC061DF3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011" t="30145" r="6727" b="29507"/>
          <a:stretch/>
        </p:blipFill>
        <p:spPr>
          <a:xfrm>
            <a:off x="747421" y="1900362"/>
            <a:ext cx="7744571" cy="276705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AA46100-5E92-F441-9333-E24C36181EAA}"/>
              </a:ext>
            </a:extLst>
          </p:cNvPr>
          <p:cNvSpPr txBox="1"/>
          <p:nvPr/>
        </p:nvSpPr>
        <p:spPr>
          <a:xfrm>
            <a:off x="739468" y="2027582"/>
            <a:ext cx="2623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6776353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</TotalTime>
  <Words>38</Words>
  <Application>Microsoft Macintosh PowerPoint</Application>
  <PresentationFormat>On-screen Show (4:3)</PresentationFormat>
  <Paragraphs>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tenbach, Susan - ARS</dc:creator>
  <cp:lastModifiedBy>Altenbach, Susan - ARS</cp:lastModifiedBy>
  <cp:revision>2</cp:revision>
  <cp:lastPrinted>2018-09-29T00:58:03Z</cp:lastPrinted>
  <dcterms:created xsi:type="dcterms:W3CDTF">2018-09-29T00:54:50Z</dcterms:created>
  <dcterms:modified xsi:type="dcterms:W3CDTF">2018-09-29T01:08:36Z</dcterms:modified>
</cp:coreProperties>
</file>